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9" r:id="rId2"/>
    <p:sldId id="273" r:id="rId3"/>
    <p:sldId id="300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9900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5943" autoAdjust="0"/>
  </p:normalViewPr>
  <p:slideViewPr>
    <p:cSldViewPr snapToGrid="0">
      <p:cViewPr varScale="1">
        <p:scale>
          <a:sx n="101" d="100"/>
          <a:sy n="101" d="100"/>
        </p:scale>
        <p:origin x="-120" y="-90"/>
      </p:cViewPr>
      <p:guideLst>
        <p:guide orient="horz" pos="2160"/>
        <p:guide pos="384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03E9DA-A8D6-49FC-94CE-53C5398E329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C016F8-F2BC-4B9E-AC29-577059855E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037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13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653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6964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44608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670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49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8194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039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17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0489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8343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339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820159"/>
              </p:ext>
            </p:extLst>
          </p:nvPr>
        </p:nvGraphicFramePr>
        <p:xfrm>
          <a:off x="203200" y="1134378"/>
          <a:ext cx="8826502" cy="28238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6583"/>
                <a:gridCol w="777362"/>
                <a:gridCol w="638009"/>
                <a:gridCol w="548290"/>
                <a:gridCol w="548290"/>
                <a:gridCol w="560751"/>
                <a:gridCol w="717759"/>
                <a:gridCol w="548290"/>
                <a:gridCol w="638709"/>
                <a:gridCol w="666388"/>
                <a:gridCol w="687772"/>
                <a:gridCol w="673100"/>
                <a:gridCol w="965199"/>
              </a:tblGrid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omosom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Intergeni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Promot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3' UT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5' UT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Calibri" panose="020F0502020204030204" pitchFamily="34" charset="0"/>
                        </a:rPr>
                        <a:t>Intr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Non-</a:t>
                      </a:r>
                      <a:r>
                        <a:rPr lang="en-US" sz="1100" u="none" strike="noStrike" dirty="0" err="1">
                          <a:effectLst/>
                          <a:latin typeface="Calibri" panose="020F0502020204030204" pitchFamily="34" charset="0"/>
                        </a:rPr>
                        <a:t>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Calibri" panose="020F0502020204030204" pitchFamily="34" charset="0"/>
                        </a:rPr>
                        <a:t>Sy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Splicing </a:t>
                      </a:r>
                      <a:endParaRPr lang="en-US" sz="1100" u="none" strike="noStrike" dirty="0" smtClean="0"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vari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Start-ga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Start-los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Calibri" panose="020F0502020204030204" pitchFamily="34" charset="0"/>
                        </a:rPr>
                        <a:t>Stop-ga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Stop-los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998,21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777,03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30,47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4,52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40,68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33,85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5,52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5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,60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8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87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30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549,0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577,14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1,23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1,346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13,11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24,111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7,74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1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,09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61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483,61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574,10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8,90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9,58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99,63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9,26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4,09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73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7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6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791,83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488,91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0,77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1,25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91,586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4,04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6,62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,21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5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64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415,04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441,203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4,507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7,57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71,59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5,79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1,731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1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34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3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0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3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603,26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497,684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8,353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9,0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93,15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2,54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6,39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6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73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65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558,16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460,369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6,969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9,25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87,236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1,86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5,93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5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,73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5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3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621,68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459,08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8,039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0,253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86,66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0,2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4,66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5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,00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59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4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0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194,22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333,628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1,475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6,238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67,983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4,49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10,74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2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19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37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3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305,60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365,701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4,550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7,691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77,20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7,899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2,620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3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50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4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51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4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695,00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487,941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24,868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0,717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16,870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31,77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 dirty="0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 dirty="0">
                          <a:effectLst/>
                          <a:latin typeface="Calibri" panose="020F0502020204030204" pitchFamily="34" charset="0"/>
                        </a:rPr>
                        <a:t>22,2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9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,16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6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89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26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noFill/>
                  </a:tcPr>
                </a:tc>
              </a:tr>
              <a:tr h="206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Chr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592,58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393,335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6,705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9,287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74,654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20,597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Calibri" panose="020F0502020204030204" pitchFamily="34" charset="0"/>
                        </a:rPr>
                        <a:t>    </a:t>
                      </a:r>
                      <a:r>
                        <a:rPr lang="en-US" altLang="ko-KR" sz="1100" u="none" strike="noStrike">
                          <a:effectLst/>
                          <a:latin typeface="Calibri" panose="020F0502020204030204" pitchFamily="34" charset="0"/>
                        </a:rPr>
                        <a:t>14,892 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6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,82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3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58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17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6692" marR="6692" marT="892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177803" y="769035"/>
            <a:ext cx="83947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Table S3</a:t>
            </a:r>
            <a:r>
              <a:rPr lang="en-US" sz="1400" dirty="0" smtClean="0">
                <a:latin typeface="Calibri" panose="020F0502020204030204" pitchFamily="34" charset="0"/>
              </a:rPr>
              <a:t>. </a:t>
            </a:r>
            <a:r>
              <a:rPr lang="en-US" sz="1400" dirty="0">
                <a:latin typeface="Calibri" panose="020F0502020204030204" pitchFamily="34" charset="0"/>
              </a:rPr>
              <a:t>SNP distributions across various rice genomic regions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661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0178994"/>
              </p:ext>
            </p:extLst>
          </p:nvPr>
        </p:nvGraphicFramePr>
        <p:xfrm>
          <a:off x="126999" y="1442743"/>
          <a:ext cx="8699502" cy="30270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501"/>
                <a:gridCol w="749300"/>
                <a:gridCol w="660400"/>
                <a:gridCol w="635000"/>
                <a:gridCol w="558800"/>
                <a:gridCol w="800100"/>
                <a:gridCol w="1066800"/>
                <a:gridCol w="508000"/>
                <a:gridCol w="800100"/>
                <a:gridCol w="584200"/>
                <a:gridCol w="596900"/>
                <a:gridCol w="368300"/>
                <a:gridCol w="546101"/>
              </a:tblGrid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Chromosom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Intergeni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Promot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Intr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3' UT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5' UT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Codon </a:t>
                      </a:r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Insertion</a:t>
                      </a: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/dele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Frame</a:t>
                      </a: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shif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Splicing </a:t>
                      </a:r>
                      <a:endParaRPr lang="en-US" sz="1100" u="none" strike="noStrike" dirty="0" smtClean="0"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vari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Start</a:t>
                      </a: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gained</a:t>
                      </a: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/</a:t>
                      </a:r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los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Stop</a:t>
                      </a: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gained</a:t>
                      </a:r>
                    </a:p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/</a:t>
                      </a:r>
                      <a:r>
                        <a:rPr lang="en-US" sz="1100" u="none" strike="noStrike" dirty="0">
                          <a:effectLst/>
                          <a:latin typeface="Calibri" panose="020F0502020204030204" pitchFamily="34" charset="0"/>
                        </a:rPr>
                        <a:t>los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 smtClean="0">
                          <a:effectLst/>
                          <a:latin typeface="Calibri" panose="020F0502020204030204" pitchFamily="34" charset="0"/>
                        </a:rPr>
                        <a:t>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Calibri" panose="020F0502020204030204" pitchFamily="34" charset="0"/>
                        </a:rPr>
                        <a:t>Non-</a:t>
                      </a:r>
                      <a:r>
                        <a:rPr lang="en-US" sz="1100" u="none" strike="noStrike" dirty="0" err="1" smtClean="0">
                          <a:effectLst/>
                          <a:latin typeface="Calibri" panose="020F0502020204030204" pitchFamily="34" charset="0"/>
                        </a:rPr>
                        <a:t>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1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57,804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55,209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2,064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,411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,027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193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990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599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49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1 </a:t>
                      </a: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2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2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8,41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14,10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5,27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,70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34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61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48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9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2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11 </a:t>
                      </a: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3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56,52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12,80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3,17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,40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12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43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20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7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0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4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8,67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0,34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9,62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92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57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5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65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4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7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26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5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18,80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2,54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5,82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26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21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00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7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8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6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2,08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5,90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9,48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78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42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54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0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3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7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4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2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7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48,93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6,89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9,03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82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45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5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23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8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8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59,69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8,07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8,80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58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80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4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26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53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8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5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0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1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09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85,33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2,65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4,07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53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636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0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4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5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03 </a:t>
                      </a: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10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04,57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5,941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4,919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62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72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8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02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8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73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7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11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76,12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3,157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2,71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,452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50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73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765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84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0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8 </a:t>
                      </a: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72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Ch12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54,687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75,648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6,044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3,376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,480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318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</a:t>
                      </a:r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1,238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545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90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       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63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4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263 </a:t>
                      </a:r>
                    </a:p>
                  </a:txBody>
                  <a:tcPr marL="7144" marR="7144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139700" y="1014512"/>
            <a:ext cx="83566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Table S4</a:t>
            </a:r>
            <a:r>
              <a:rPr lang="en-US" sz="1400" dirty="0" smtClean="0">
                <a:latin typeface="Calibri" panose="020F0502020204030204" pitchFamily="34" charset="0"/>
              </a:rPr>
              <a:t>. </a:t>
            </a:r>
            <a:r>
              <a:rPr lang="en-US" sz="1400" dirty="0">
                <a:latin typeface="Calibri" panose="020F0502020204030204" pitchFamily="34" charset="0"/>
              </a:rPr>
              <a:t>INDEL distributions across various KRICE_CORE genomic regions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1367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5651237"/>
              </p:ext>
            </p:extLst>
          </p:nvPr>
        </p:nvGraphicFramePr>
        <p:xfrm>
          <a:off x="1263650" y="1403755"/>
          <a:ext cx="7086599" cy="4270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14311"/>
                <a:gridCol w="1281489"/>
                <a:gridCol w="3290799"/>
              </a:tblGrid>
              <a:tr h="2970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Ter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Count </a:t>
                      </a:r>
                    </a:p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(Enrichment score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Representative </a:t>
                      </a:r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functions (p value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Abiotic stres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4 (1.9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Response to abiotic stres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Response to water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err="1">
                          <a:effectLst/>
                          <a:latin typeface="Calibri" panose="020F0502020204030204" pitchFamily="34" charset="0"/>
                        </a:rPr>
                        <a:t>Dehydr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Energy production and conversion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4 (1.6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UDP-N-</a:t>
                      </a:r>
                      <a:r>
                        <a:rPr lang="en-US" sz="1100" b="0" u="none" strike="noStrike" dirty="0" err="1">
                          <a:effectLst/>
                          <a:latin typeface="Calibri" panose="020F0502020204030204" pitchFamily="34" charset="0"/>
                        </a:rPr>
                        <a:t>acetylmuramate</a:t>
                      </a:r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 dehydrogenase activity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Flavin adenine dinucleotide binding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noFill/>
                  </a:tcPr>
                </a:tc>
              </a:tr>
              <a:tr h="3518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Oxidoreductase activity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atalytic activity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17 (1.6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ellular biogenic amine metabolic proces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Phosphoric </a:t>
                      </a:r>
                      <a:r>
                        <a:rPr lang="en-US" sz="1100" b="0" u="none" strike="noStrike" dirty="0" err="1">
                          <a:effectLst/>
                          <a:latin typeface="Calibri" panose="020F0502020204030204" pitchFamily="34" charset="0"/>
                        </a:rPr>
                        <a:t>diester</a:t>
                      </a:r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 hydrolase activ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alcium-dependent membrane target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noFill/>
                  </a:tcPr>
                </a:tc>
              </a:tr>
              <a:tr h="32540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Phospholipid metabolic proces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Biotic stress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3 (1.2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Antibacterial peptide activ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2618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Defense response to fungu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Binding activit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12 (1.1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oenzyme bind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3629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ofactor bind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9063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Protein</a:t>
                      </a:r>
                      <a:r>
                        <a:rPr lang="en-US" sz="1100" b="0" u="none" strike="noStrike" baseline="0" dirty="0" smtClean="0">
                          <a:effectLst/>
                          <a:latin typeface="Calibri" panose="020F0502020204030204" pitchFamily="34" charset="0"/>
                        </a:rPr>
                        <a:t> transport</a:t>
                      </a:r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5 (0.7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Integral </a:t>
                      </a:r>
                      <a:r>
                        <a:rPr lang="en-US" sz="1100" b="0" u="none" strike="noStrike" dirty="0">
                          <a:effectLst/>
                          <a:latin typeface="Calibri" panose="020F0502020204030204" pitchFamily="34" charset="0"/>
                        </a:rPr>
                        <a:t>component of plasma </a:t>
                      </a:r>
                      <a:r>
                        <a:rPr lang="en-US" sz="1100" b="0" u="none" strike="noStrike" dirty="0" smtClean="0">
                          <a:effectLst/>
                          <a:latin typeface="Calibri" panose="020F0502020204030204" pitchFamily="34" charset="0"/>
                        </a:rPr>
                        <a:t>membrane</a:t>
                      </a: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맑은 고딕" panose="020B0503020000020004" pitchFamily="50" charset="-127"/>
                        </a:rPr>
                        <a:t>Protein localiz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144" marR="7144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1079500" y="521900"/>
            <a:ext cx="7416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smtClean="0">
                <a:latin typeface="Calibri" panose="020F0502020204030204" pitchFamily="34" charset="0"/>
              </a:rPr>
              <a:t>Table S5</a:t>
            </a:r>
            <a:r>
              <a:rPr lang="en-US" sz="1400" dirty="0" smtClean="0">
                <a:latin typeface="Calibri" panose="020F0502020204030204" pitchFamily="34" charset="0"/>
              </a:rPr>
              <a:t>. </a:t>
            </a:r>
            <a:r>
              <a:rPr lang="en-US" sz="1400" dirty="0">
                <a:latin typeface="Calibri" panose="020F0502020204030204" pitchFamily="34" charset="0"/>
              </a:rPr>
              <a:t>Functional categories enriched in the high SNP/INDEL region across the KRICE_CORE genomes</a:t>
            </a:r>
          </a:p>
        </p:txBody>
      </p:sp>
    </p:spTree>
    <p:extLst>
      <p:ext uri="{BB962C8B-B14F-4D97-AF65-F5344CB8AC3E}">
        <p14:creationId xmlns:p14="http://schemas.microsoft.com/office/powerpoint/2010/main" val="2024178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10</TotalTime>
  <Words>692</Words>
  <Application>Microsoft Office PowerPoint</Application>
  <PresentationFormat>On-screen Show (4:3)</PresentationFormat>
  <Paragraphs>38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태성</dc:creator>
  <cp:lastModifiedBy>Abella, Jerard Dave</cp:lastModifiedBy>
  <cp:revision>85</cp:revision>
  <dcterms:created xsi:type="dcterms:W3CDTF">2015-01-07T06:16:14Z</dcterms:created>
  <dcterms:modified xsi:type="dcterms:W3CDTF">2016-05-17T11:46:37Z</dcterms:modified>
</cp:coreProperties>
</file>